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61" r:id="rId4"/>
    <p:sldId id="262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8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685FC4-89CB-D49F-108A-48546FD8C8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582AFAD-5357-D268-96B4-AD81BAABAD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C6B51F-6F32-7E07-BD13-FB6F55D5F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B3EF04-4A07-5423-D163-77DA30AA04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91D019-B76A-4625-A2C7-2F51CC001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7065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64AD1A-9329-EF7F-627E-446A1A9EF7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9026AE2-BA4C-6E2C-29FC-B127D3D3C0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DE2E75-AF1E-51A2-D6E4-BAD331BAA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FD35E8-5EB2-AC6A-32D1-4A16A960D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E215C9-1EA1-430B-6D0E-27A90701D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0113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DF52BD9-F3FA-C96C-AB06-3855E9EA59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93B19C8-BF90-5D1D-A499-3FC904C05A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050957-F479-1E0D-90F7-B17B5984B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571D4A-5EEE-491F-558B-31309A1AA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FF800D-5EE4-A875-6453-70114B8F9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2482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E46B5E-4ABC-76DF-D10F-7CB24E8AAA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F1D36F-030B-BBF2-6CD5-5054F71BA0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47E3C0-9606-B41D-DE48-E541D9064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D01251-F6BF-CD00-8D7A-DD40D31D1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A4E675-A077-815E-2660-09D0DB78F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0994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D44832-3DDC-1B05-66B8-CFA9A78435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188C304-1F36-5A47-6A7C-4FF9B88D42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A40813-A8FE-1EC3-A002-8BD5C94B1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BE8381-A1B6-6F52-5984-0158E62EE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87A9BB-C66D-79B9-DF86-22F521268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5111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B184FA-A9DE-8443-5E4A-45331B493D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B08BEA-0CF2-EDD3-601F-7666BCAC2D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44D8244-1E38-9C76-EF1D-53957E8012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CD31FC4-644E-CEC6-44E6-9A3220FA6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89BCD3B-7886-3731-92B4-45BA4BBC0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86304E4-39E3-43A3-44E6-288195BCF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5057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D4EADC-08D8-68B4-8104-921BF937DE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C82252F-350A-7976-BE02-C32BD757EA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D4A86F5-D1DC-7BAB-DB10-EE88A744CA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92E28FD-8935-EF20-C05D-9E2B3B39BE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117D4B5-8565-C5CE-0CD8-D8A61FEDD5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9A1B64A-DD6D-8756-4AE8-36F68DECE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48CF539-16A3-A909-D458-22494FFF9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9064D01-81F5-84B0-EA30-973F1DF2B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8542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7B3501-E6A9-6AFB-AC5A-6E12AF236A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6DEA6F4-352C-8D17-2B00-4365F8E25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B82FC0D-820A-28B8-A018-E3E454AFE9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AB0D584-68D0-96FA-A075-1ADE5917D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0243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1C822E9-8A12-A63A-B900-E5042C0DE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A037D9C-4009-9992-64AF-9450D59A1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A3FBD6B-6E79-DBE9-A3B7-235037C71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7739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2F346B-88E9-8600-203D-678B2CABB9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CDA632C-012B-A7BD-B617-4AD1D58E21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B27B582-FE7D-4C75-6967-F8405A0051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4DCEEA4-5C8B-99E9-A6B4-CA36BBCA0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C80BAB-05B2-4518-0D6E-4A64AD1D26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CC66B97-6FCC-27E0-0A8F-B062DC2EC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1232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FBA0FC-E7C2-03A0-79EA-7E0CA013F3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F54DC2A-D960-7300-B4B1-1407AEF593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11CA489-AF5F-4B76-EA81-0878D478E7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60CD07A-8A0B-2A5F-D943-EF51E9591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6A14630-32AD-A5DC-1CFB-64E12DE8A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B594C65-0F6C-ADAF-EC31-469CE81EE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2602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6A7B1C4-6178-B6EF-245B-1A5E54C53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6241471-B64A-79AB-B24B-7B382311A5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9DA528-9A61-FB69-3FCA-0CD4A5428A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9BEF1-D914-42F3-A019-14E397635809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76E8A2-D3E3-CC6E-7CC7-EB9D06304F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C4883B-B265-0A02-43CE-9898463168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BB100-E68B-47D6-9741-049857DFCF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1810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image" Target="../media/image4.png"/><Relationship Id="rId3" Type="http://schemas.openxmlformats.org/officeDocument/2006/relationships/tags" Target="../tags/tag3.xml"/><Relationship Id="rId7" Type="http://schemas.openxmlformats.org/officeDocument/2006/relationships/tags" Target="../tags/tag7.xml"/><Relationship Id="rId12" Type="http://schemas.openxmlformats.org/officeDocument/2006/relationships/image" Target="../media/image3.tiff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image" Target="../media/image2.tiff"/><Relationship Id="rId5" Type="http://schemas.openxmlformats.org/officeDocument/2006/relationships/tags" Target="../tags/tag5.xml"/><Relationship Id="rId15" Type="http://schemas.openxmlformats.org/officeDocument/2006/relationships/image" Target="../media/image6.png"/><Relationship Id="rId10" Type="http://schemas.openxmlformats.org/officeDocument/2006/relationships/image" Target="../media/image1.tiff"/><Relationship Id="rId4" Type="http://schemas.openxmlformats.org/officeDocument/2006/relationships/tags" Target="../tags/tag4.xml"/><Relationship Id="rId9" Type="http://schemas.openxmlformats.org/officeDocument/2006/relationships/slideLayout" Target="../slideLayouts/slideLayout7.xml"/><Relationship Id="rId14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tags" Target="../tags/tag16.xml"/><Relationship Id="rId13" Type="http://schemas.openxmlformats.org/officeDocument/2006/relationships/image" Target="../media/image9.png"/><Relationship Id="rId3" Type="http://schemas.openxmlformats.org/officeDocument/2006/relationships/tags" Target="../tags/tag11.xml"/><Relationship Id="rId7" Type="http://schemas.openxmlformats.org/officeDocument/2006/relationships/tags" Target="../tags/tag15.xml"/><Relationship Id="rId12" Type="http://schemas.openxmlformats.org/officeDocument/2006/relationships/image" Target="../media/image8.png"/><Relationship Id="rId2" Type="http://schemas.openxmlformats.org/officeDocument/2006/relationships/tags" Target="../tags/tag10.xml"/><Relationship Id="rId1" Type="http://schemas.openxmlformats.org/officeDocument/2006/relationships/tags" Target="../tags/tag9.xml"/><Relationship Id="rId6" Type="http://schemas.openxmlformats.org/officeDocument/2006/relationships/tags" Target="../tags/tag14.xml"/><Relationship Id="rId11" Type="http://schemas.openxmlformats.org/officeDocument/2006/relationships/image" Target="../media/image4.png"/><Relationship Id="rId5" Type="http://schemas.openxmlformats.org/officeDocument/2006/relationships/tags" Target="../tags/tag13.xml"/><Relationship Id="rId15" Type="http://schemas.openxmlformats.org/officeDocument/2006/relationships/image" Target="../media/image11.tiff"/><Relationship Id="rId10" Type="http://schemas.openxmlformats.org/officeDocument/2006/relationships/image" Target="../media/image7.tiff"/><Relationship Id="rId4" Type="http://schemas.openxmlformats.org/officeDocument/2006/relationships/tags" Target="../tags/tag12.xml"/><Relationship Id="rId9" Type="http://schemas.openxmlformats.org/officeDocument/2006/relationships/slideLayout" Target="../slideLayouts/slideLayout7.xml"/><Relationship Id="rId14" Type="http://schemas.openxmlformats.org/officeDocument/2006/relationships/image" Target="../media/image10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24.xml"/><Relationship Id="rId13" Type="http://schemas.openxmlformats.org/officeDocument/2006/relationships/image" Target="../media/image4.png"/><Relationship Id="rId3" Type="http://schemas.openxmlformats.org/officeDocument/2006/relationships/tags" Target="../tags/tag19.xml"/><Relationship Id="rId7" Type="http://schemas.openxmlformats.org/officeDocument/2006/relationships/tags" Target="../tags/tag23.xml"/><Relationship Id="rId12" Type="http://schemas.openxmlformats.org/officeDocument/2006/relationships/image" Target="../media/image14.tiff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tags" Target="../tags/tag22.xml"/><Relationship Id="rId11" Type="http://schemas.openxmlformats.org/officeDocument/2006/relationships/image" Target="../media/image13.tiff"/><Relationship Id="rId5" Type="http://schemas.openxmlformats.org/officeDocument/2006/relationships/tags" Target="../tags/tag21.xml"/><Relationship Id="rId15" Type="http://schemas.openxmlformats.org/officeDocument/2006/relationships/image" Target="../media/image16.png"/><Relationship Id="rId10" Type="http://schemas.openxmlformats.org/officeDocument/2006/relationships/image" Target="../media/image12.tiff"/><Relationship Id="rId4" Type="http://schemas.openxmlformats.org/officeDocument/2006/relationships/tags" Target="../tags/tag20.xml"/><Relationship Id="rId9" Type="http://schemas.openxmlformats.org/officeDocument/2006/relationships/slideLayout" Target="../slideLayouts/slideLayout7.xml"/><Relationship Id="rId1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32.xml"/><Relationship Id="rId13" Type="http://schemas.openxmlformats.org/officeDocument/2006/relationships/image" Target="../media/image4.png"/><Relationship Id="rId3" Type="http://schemas.openxmlformats.org/officeDocument/2006/relationships/tags" Target="../tags/tag27.xml"/><Relationship Id="rId7" Type="http://schemas.openxmlformats.org/officeDocument/2006/relationships/tags" Target="../tags/tag31.xml"/><Relationship Id="rId12" Type="http://schemas.openxmlformats.org/officeDocument/2006/relationships/image" Target="../media/image19.tiff"/><Relationship Id="rId2" Type="http://schemas.openxmlformats.org/officeDocument/2006/relationships/tags" Target="../tags/tag26.xml"/><Relationship Id="rId1" Type="http://schemas.openxmlformats.org/officeDocument/2006/relationships/tags" Target="../tags/tag25.xml"/><Relationship Id="rId6" Type="http://schemas.openxmlformats.org/officeDocument/2006/relationships/tags" Target="../tags/tag30.xml"/><Relationship Id="rId11" Type="http://schemas.openxmlformats.org/officeDocument/2006/relationships/image" Target="../media/image18.tiff"/><Relationship Id="rId5" Type="http://schemas.openxmlformats.org/officeDocument/2006/relationships/tags" Target="../tags/tag29.xml"/><Relationship Id="rId15" Type="http://schemas.openxmlformats.org/officeDocument/2006/relationships/image" Target="../media/image21.png"/><Relationship Id="rId10" Type="http://schemas.openxmlformats.org/officeDocument/2006/relationships/image" Target="../media/image17.tiff"/><Relationship Id="rId4" Type="http://schemas.openxmlformats.org/officeDocument/2006/relationships/tags" Target="../tags/tag28.xml"/><Relationship Id="rId9" Type="http://schemas.openxmlformats.org/officeDocument/2006/relationships/slideLayout" Target="../slideLayouts/slideLayout7.xml"/><Relationship Id="rId1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9430553-58D5-9B0F-7EF2-E33F33C371F3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01" t="23020" r="42682" b="15742"/>
          <a:stretch/>
        </p:blipFill>
        <p:spPr>
          <a:xfrm>
            <a:off x="6398823" y="1974056"/>
            <a:ext cx="2723137" cy="310467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201CD31-CA18-3D72-A75F-E9ECB82339B8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49" t="25233" r="43157" b="13529"/>
          <a:stretch/>
        </p:blipFill>
        <p:spPr>
          <a:xfrm>
            <a:off x="9121960" y="1878397"/>
            <a:ext cx="2923719" cy="320990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B73C23A-A9B1-F591-50BE-7AA1EF7A5D0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67" t="20845" r="43316" b="7735"/>
          <a:stretch/>
        </p:blipFill>
        <p:spPr>
          <a:xfrm>
            <a:off x="3482493" y="1946954"/>
            <a:ext cx="2432204" cy="323403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F18C76D-3400-95EB-2A34-7F83EDB79109}"/>
              </a:ext>
            </a:extLst>
          </p:cNvPr>
          <p:cNvSpPr txBox="1"/>
          <p:nvPr/>
        </p:nvSpPr>
        <p:spPr>
          <a:xfrm>
            <a:off x="2563915" y="3275111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AKT 60KD</a:t>
            </a:r>
            <a:endParaRPr lang="zh-CN" altLang="en-US" sz="1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4038155-C88E-5BF1-5B20-0E7E668345AD}"/>
              </a:ext>
            </a:extLst>
          </p:cNvPr>
          <p:cNvSpPr txBox="1"/>
          <p:nvPr/>
        </p:nvSpPr>
        <p:spPr>
          <a:xfrm>
            <a:off x="4386756" y="744279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1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F7CBCD5-B054-0EFF-5B43-8E0A62792232}"/>
              </a:ext>
            </a:extLst>
          </p:cNvPr>
          <p:cNvSpPr txBox="1"/>
          <p:nvPr/>
        </p:nvSpPr>
        <p:spPr>
          <a:xfrm>
            <a:off x="7058336" y="744279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2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7F861F9-7E10-29A5-137D-79BCDD7A1508}"/>
              </a:ext>
            </a:extLst>
          </p:cNvPr>
          <p:cNvSpPr txBox="1"/>
          <p:nvPr/>
        </p:nvSpPr>
        <p:spPr>
          <a:xfrm>
            <a:off x="9960707" y="696416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3</a:t>
            </a:r>
            <a:endParaRPr lang="zh-CN" altLang="en-US" dirty="0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35E2148A-C312-4D0B-F818-05EBB054255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578" y="2312657"/>
            <a:ext cx="640574" cy="240587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888DA02B-4571-B0DD-D954-24FF76344027}"/>
              </a:ext>
            </a:extLst>
          </p:cNvPr>
          <p:cNvSpPr txBox="1"/>
          <p:nvPr/>
        </p:nvSpPr>
        <p:spPr>
          <a:xfrm>
            <a:off x="609193" y="4756284"/>
            <a:ext cx="12478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Marker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DC4F6C5-E933-5C54-250A-7C26E75098F1}"/>
              </a:ext>
            </a:extLst>
          </p:cNvPr>
          <p:cNvSpPr txBox="1"/>
          <p:nvPr/>
        </p:nvSpPr>
        <p:spPr>
          <a:xfrm rot="18777364">
            <a:off x="4011443" y="1929533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BE1E3F7-DF5A-169A-EAD6-778E4A92E88A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 rot="18777364">
            <a:off x="4289205" y="1627777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0FC4740B-1923-9BB3-1355-18FDBB7084FB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 rot="18777364">
            <a:off x="4702035" y="1692309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9B11C53-65C6-FA73-6960-18670FAA0DE5}"/>
              </a:ext>
            </a:extLst>
          </p:cNvPr>
          <p:cNvSpPr txBox="1"/>
          <p:nvPr/>
        </p:nvSpPr>
        <p:spPr>
          <a:xfrm rot="18777364">
            <a:off x="7005581" y="1725464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01F1E1C-D463-7891-A602-AECD4ADE0CFA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 rot="18777364">
            <a:off x="7283343" y="1423708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95B4135-F47B-5552-0C8E-8D535A9C0BC2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 rot="18777364">
            <a:off x="7696173" y="1488240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751A880-7ED8-0FAC-205D-4852DA821490}"/>
              </a:ext>
            </a:extLst>
          </p:cNvPr>
          <p:cNvSpPr txBox="1"/>
          <p:nvPr/>
        </p:nvSpPr>
        <p:spPr>
          <a:xfrm rot="18777364">
            <a:off x="9969226" y="1616345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B8CD271-0503-6240-54A2-D193AFA02E88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 rot="18777364">
            <a:off x="10246988" y="1314589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0E942259-CFD3-E6A3-9DD8-6385E42F58D7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 rot="18777364">
            <a:off x="10659818" y="1379121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graphicFrame>
        <p:nvGraphicFramePr>
          <p:cNvPr id="54" name="表格 53">
            <a:extLst>
              <a:ext uri="{FF2B5EF4-FFF2-40B4-BE49-F238E27FC236}">
                <a16:creationId xmlns:a16="http://schemas.microsoft.com/office/drawing/2014/main" id="{306680DC-8BB3-D070-3156-F14B4BB014E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323984693"/>
              </p:ext>
            </p:extLst>
          </p:nvPr>
        </p:nvGraphicFramePr>
        <p:xfrm>
          <a:off x="3388864" y="6087612"/>
          <a:ext cx="829410" cy="271780"/>
        </p:xfrm>
        <a:graphic>
          <a:graphicData uri="http://schemas.openxmlformats.org/drawingml/2006/table">
            <a:tbl>
              <a:tblPr/>
              <a:tblGrid>
                <a:gridCol w="8294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AKT        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55" name="表格 54">
            <a:extLst>
              <a:ext uri="{FF2B5EF4-FFF2-40B4-BE49-F238E27FC236}">
                <a16:creationId xmlns:a16="http://schemas.microsoft.com/office/drawing/2014/main" id="{9AA569CA-0D6D-3DA8-2284-12CBE7D17DC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66343435"/>
              </p:ext>
            </p:extLst>
          </p:nvPr>
        </p:nvGraphicFramePr>
        <p:xfrm>
          <a:off x="3246186" y="6442080"/>
          <a:ext cx="918185" cy="271780"/>
        </p:xfrm>
        <a:graphic>
          <a:graphicData uri="http://schemas.openxmlformats.org/drawingml/2006/table">
            <a:tbl>
              <a:tblPr/>
              <a:tblGrid>
                <a:gridCol w="9181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GAPDH     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56" name="图片 55">
            <a:extLst>
              <a:ext uri="{FF2B5EF4-FFF2-40B4-BE49-F238E27FC236}">
                <a16:creationId xmlns:a16="http://schemas.microsoft.com/office/drawing/2014/main" id="{985029FB-1E2F-0642-E086-A88463ED3DA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99933" y="6416046"/>
            <a:ext cx="1504921" cy="308604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5D94322A-2909-1236-37ED-ABD86959DC3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092314" y="6043842"/>
            <a:ext cx="1508731" cy="331464"/>
          </a:xfrm>
          <a:prstGeom prst="rect">
            <a:avLst/>
          </a:prstGeom>
        </p:spPr>
      </p:pic>
      <p:sp>
        <p:nvSpPr>
          <p:cNvPr id="58" name="文本框 57">
            <a:extLst>
              <a:ext uri="{FF2B5EF4-FFF2-40B4-BE49-F238E27FC236}">
                <a16:creationId xmlns:a16="http://schemas.microsoft.com/office/drawing/2014/main" id="{DC03CF8A-BD02-638A-A3C1-9607A3FF4C1D}"/>
              </a:ext>
            </a:extLst>
          </p:cNvPr>
          <p:cNvSpPr txBox="1"/>
          <p:nvPr/>
        </p:nvSpPr>
        <p:spPr>
          <a:xfrm>
            <a:off x="1576858" y="6190640"/>
            <a:ext cx="1580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n manuscript:</a:t>
            </a:r>
            <a:endParaRPr lang="zh-CN" altLang="en-US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674CA38B-DDE7-6581-58EE-518D8CA53874}"/>
              </a:ext>
            </a:extLst>
          </p:cNvPr>
          <p:cNvSpPr txBox="1"/>
          <p:nvPr/>
        </p:nvSpPr>
        <p:spPr>
          <a:xfrm rot="18777364">
            <a:off x="4167913" y="5531320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95FA0159-BF7D-F66D-3419-4A94A100F428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 rot="18777364">
            <a:off x="4434736" y="5198739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9D92115B-17BA-523F-E888-4E904D1563A4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 rot="18777364">
            <a:off x="4943634" y="5288957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</p:spTree>
    <p:extLst>
      <p:ext uri="{BB962C8B-B14F-4D97-AF65-F5344CB8AC3E}">
        <p14:creationId xmlns:p14="http://schemas.microsoft.com/office/powerpoint/2010/main" val="35537128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图片 22">
            <a:extLst>
              <a:ext uri="{FF2B5EF4-FFF2-40B4-BE49-F238E27FC236}">
                <a16:creationId xmlns:a16="http://schemas.microsoft.com/office/drawing/2014/main" id="{78F8A251-4744-E881-6DB5-304E00200F33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76" t="35924" r="43462" b="6458"/>
          <a:stretch/>
        </p:blipFill>
        <p:spPr>
          <a:xfrm>
            <a:off x="3439576" y="2314347"/>
            <a:ext cx="2332788" cy="261505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F18C76D-3400-95EB-2A34-7F83EDB79109}"/>
              </a:ext>
            </a:extLst>
          </p:cNvPr>
          <p:cNvSpPr txBox="1"/>
          <p:nvPr/>
        </p:nvSpPr>
        <p:spPr>
          <a:xfrm>
            <a:off x="2367299" y="3398539"/>
            <a:ext cx="11448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AKT 60KD</a:t>
            </a:r>
            <a:endParaRPr lang="zh-CN" altLang="en-US" sz="1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4038155-C88E-5BF1-5B20-0E7E668345AD}"/>
              </a:ext>
            </a:extLst>
          </p:cNvPr>
          <p:cNvSpPr txBox="1"/>
          <p:nvPr/>
        </p:nvSpPr>
        <p:spPr>
          <a:xfrm>
            <a:off x="4386756" y="744279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1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F7CBCD5-B054-0EFF-5B43-8E0A62792232}"/>
              </a:ext>
            </a:extLst>
          </p:cNvPr>
          <p:cNvSpPr txBox="1"/>
          <p:nvPr/>
        </p:nvSpPr>
        <p:spPr>
          <a:xfrm>
            <a:off x="7058336" y="744279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2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7F861F9-7E10-29A5-137D-79BCDD7A1508}"/>
              </a:ext>
            </a:extLst>
          </p:cNvPr>
          <p:cNvSpPr txBox="1"/>
          <p:nvPr/>
        </p:nvSpPr>
        <p:spPr>
          <a:xfrm>
            <a:off x="9960707" y="696416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3</a:t>
            </a:r>
            <a:endParaRPr lang="zh-CN" altLang="en-US" dirty="0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35E2148A-C312-4D0B-F818-05EBB054255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578" y="2312657"/>
            <a:ext cx="640574" cy="240587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888DA02B-4571-B0DD-D954-24FF76344027}"/>
              </a:ext>
            </a:extLst>
          </p:cNvPr>
          <p:cNvSpPr txBox="1"/>
          <p:nvPr/>
        </p:nvSpPr>
        <p:spPr>
          <a:xfrm>
            <a:off x="609193" y="4756284"/>
            <a:ext cx="12478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Marker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DC4F6C5-E933-5C54-250A-7C26E75098F1}"/>
              </a:ext>
            </a:extLst>
          </p:cNvPr>
          <p:cNvSpPr txBox="1"/>
          <p:nvPr/>
        </p:nvSpPr>
        <p:spPr>
          <a:xfrm rot="18777364">
            <a:off x="4011443" y="1929533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BE1E3F7-DF5A-169A-EAD6-778E4A92E88A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 rot="18777364">
            <a:off x="4289205" y="1627777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0FC4740B-1923-9BB3-1355-18FDBB7084FB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 rot="18777364">
            <a:off x="4702035" y="1692309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9B11C53-65C6-FA73-6960-18670FAA0DE5}"/>
              </a:ext>
            </a:extLst>
          </p:cNvPr>
          <p:cNvSpPr txBox="1"/>
          <p:nvPr/>
        </p:nvSpPr>
        <p:spPr>
          <a:xfrm rot="18777364">
            <a:off x="7005581" y="1725464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01F1E1C-D463-7891-A602-AECD4ADE0CFA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 rot="18777364">
            <a:off x="7283343" y="1423708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95B4135-F47B-5552-0C8E-8D535A9C0BC2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 rot="18777364">
            <a:off x="7696173" y="1488240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DC03CF8A-BD02-638A-A3C1-9607A3FF4C1D}"/>
              </a:ext>
            </a:extLst>
          </p:cNvPr>
          <p:cNvSpPr txBox="1"/>
          <p:nvPr/>
        </p:nvSpPr>
        <p:spPr>
          <a:xfrm>
            <a:off x="1576858" y="6190640"/>
            <a:ext cx="1580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n manuscript:</a:t>
            </a:r>
            <a:endParaRPr lang="zh-CN" altLang="en-US" dirty="0"/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3E9AC174-C295-E40D-E15B-DE68C372B0D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2482581"/>
              </p:ext>
            </p:extLst>
          </p:nvPr>
        </p:nvGraphicFramePr>
        <p:xfrm>
          <a:off x="3418302" y="6076704"/>
          <a:ext cx="775970" cy="271780"/>
        </p:xfrm>
        <a:graphic>
          <a:graphicData uri="http://schemas.openxmlformats.org/drawingml/2006/table">
            <a:tbl>
              <a:tblPr/>
              <a:tblGrid>
                <a:gridCol w="7759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p-AKT      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AAAFC349-D433-D7B8-1B1D-EE1E026FF55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07709142"/>
              </p:ext>
            </p:extLst>
          </p:nvPr>
        </p:nvGraphicFramePr>
        <p:xfrm>
          <a:off x="3234224" y="6473028"/>
          <a:ext cx="1035050" cy="271780"/>
        </p:xfrm>
        <a:graphic>
          <a:graphicData uri="http://schemas.openxmlformats.org/drawingml/2006/table">
            <a:tbl>
              <a:tblPr/>
              <a:tblGrid>
                <a:gridCol w="1035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7178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GAPDH     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6" name="图片 5">
            <a:extLst>
              <a:ext uri="{FF2B5EF4-FFF2-40B4-BE49-F238E27FC236}">
                <a16:creationId xmlns:a16="http://schemas.microsoft.com/office/drawing/2014/main" id="{43C8438D-EDE9-A559-2106-327A3F24C61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59852" y="6438990"/>
            <a:ext cx="1501111" cy="33527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326E100-FB03-E372-9F40-2093927E502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67472" y="6062740"/>
            <a:ext cx="1497301" cy="320034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88952718-DE38-3C07-FA6E-71B4790F8EF4}"/>
              </a:ext>
            </a:extLst>
          </p:cNvPr>
          <p:cNvSpPr txBox="1"/>
          <p:nvPr/>
        </p:nvSpPr>
        <p:spPr>
          <a:xfrm rot="18777364">
            <a:off x="4216186" y="5552446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F690D4A-40EA-FD0A-EEF0-6E34F0EA3104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 rot="18777364">
            <a:off x="4483009" y="5219865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4489626-1ED3-191F-9E11-0368DACD3AF8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 rot="18777364">
            <a:off x="4991907" y="5310083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31CE5712-340E-BE40-697B-8952194ACC29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87" t="24454" r="45763" b="19912"/>
          <a:stretch/>
        </p:blipFill>
        <p:spPr>
          <a:xfrm>
            <a:off x="9275921" y="2067328"/>
            <a:ext cx="2412173" cy="2633307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8173B7C6-C319-6448-F2C9-BC0BEBFBF76F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30" t="22820" r="43031" b="21545"/>
          <a:stretch/>
        </p:blipFill>
        <p:spPr>
          <a:xfrm>
            <a:off x="6447684" y="2223279"/>
            <a:ext cx="2172048" cy="2584634"/>
          </a:xfrm>
          <a:prstGeom prst="rect">
            <a:avLst/>
          </a:prstGeom>
        </p:spPr>
      </p:pic>
      <p:sp>
        <p:nvSpPr>
          <p:cNvPr id="51" name="文本框 50">
            <a:extLst>
              <a:ext uri="{FF2B5EF4-FFF2-40B4-BE49-F238E27FC236}">
                <a16:creationId xmlns:a16="http://schemas.microsoft.com/office/drawing/2014/main" id="{F751A880-7ED8-0FAC-205D-4852DA821490}"/>
              </a:ext>
            </a:extLst>
          </p:cNvPr>
          <p:cNvSpPr txBox="1"/>
          <p:nvPr/>
        </p:nvSpPr>
        <p:spPr>
          <a:xfrm rot="18777364">
            <a:off x="9886337" y="1685279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B8CD271-0503-6240-54A2-D193AFA02E88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 rot="18777364">
            <a:off x="10164099" y="1383523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0E942259-CFD3-E6A3-9DD8-6385E42F58D7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 rot="18777364">
            <a:off x="10576929" y="1448055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</p:spTree>
    <p:extLst>
      <p:ext uri="{BB962C8B-B14F-4D97-AF65-F5344CB8AC3E}">
        <p14:creationId xmlns:p14="http://schemas.microsoft.com/office/powerpoint/2010/main" val="9954560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138B8ABE-C910-5149-9D6B-BCFD8B08C694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87" t="20887" r="46066" b="16085"/>
          <a:stretch/>
        </p:blipFill>
        <p:spPr>
          <a:xfrm>
            <a:off x="3442913" y="2215342"/>
            <a:ext cx="2488470" cy="3103456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81A2961D-BDCE-20AF-A799-069E2B33893D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87" t="24453" r="46866" b="22162"/>
          <a:stretch/>
        </p:blipFill>
        <p:spPr>
          <a:xfrm>
            <a:off x="6472705" y="2380136"/>
            <a:ext cx="2411613" cy="2605068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4CE034D7-CF88-18AE-3EC5-D11C780D137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46" t="25929" r="43408" b="17141"/>
          <a:stretch/>
        </p:blipFill>
        <p:spPr>
          <a:xfrm>
            <a:off x="9536480" y="2377750"/>
            <a:ext cx="2361937" cy="2720837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F18C76D-3400-95EB-2A34-7F83EDB79109}"/>
              </a:ext>
            </a:extLst>
          </p:cNvPr>
          <p:cNvSpPr txBox="1"/>
          <p:nvPr/>
        </p:nvSpPr>
        <p:spPr>
          <a:xfrm>
            <a:off x="2549620" y="2997323"/>
            <a:ext cx="9845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I3K 85KD</a:t>
            </a:r>
            <a:endParaRPr lang="zh-CN" altLang="en-US" sz="1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4038155-C88E-5BF1-5B20-0E7E668345AD}"/>
              </a:ext>
            </a:extLst>
          </p:cNvPr>
          <p:cNvSpPr txBox="1"/>
          <p:nvPr/>
        </p:nvSpPr>
        <p:spPr>
          <a:xfrm>
            <a:off x="4386756" y="744279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1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F7CBCD5-B054-0EFF-5B43-8E0A62792232}"/>
              </a:ext>
            </a:extLst>
          </p:cNvPr>
          <p:cNvSpPr txBox="1"/>
          <p:nvPr/>
        </p:nvSpPr>
        <p:spPr>
          <a:xfrm>
            <a:off x="7058336" y="744279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2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7F861F9-7E10-29A5-137D-79BCDD7A1508}"/>
              </a:ext>
            </a:extLst>
          </p:cNvPr>
          <p:cNvSpPr txBox="1"/>
          <p:nvPr/>
        </p:nvSpPr>
        <p:spPr>
          <a:xfrm>
            <a:off x="9960707" y="696416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3</a:t>
            </a:r>
            <a:endParaRPr lang="zh-CN" altLang="en-US" dirty="0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35E2148A-C312-4D0B-F818-05EBB054255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578" y="2312657"/>
            <a:ext cx="640574" cy="240587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888DA02B-4571-B0DD-D954-24FF76344027}"/>
              </a:ext>
            </a:extLst>
          </p:cNvPr>
          <p:cNvSpPr txBox="1"/>
          <p:nvPr/>
        </p:nvSpPr>
        <p:spPr>
          <a:xfrm>
            <a:off x="609193" y="4756284"/>
            <a:ext cx="12478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Marker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DC4F6C5-E933-5C54-250A-7C26E75098F1}"/>
              </a:ext>
            </a:extLst>
          </p:cNvPr>
          <p:cNvSpPr txBox="1"/>
          <p:nvPr/>
        </p:nvSpPr>
        <p:spPr>
          <a:xfrm rot="18777364">
            <a:off x="4011443" y="1929533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BE1E3F7-DF5A-169A-EAD6-778E4A92E88A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 rot="18777364">
            <a:off x="4289205" y="1627777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0FC4740B-1923-9BB3-1355-18FDBB7084FB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 rot="18777364">
            <a:off x="4702035" y="1692309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9B11C53-65C6-FA73-6960-18670FAA0DE5}"/>
              </a:ext>
            </a:extLst>
          </p:cNvPr>
          <p:cNvSpPr txBox="1"/>
          <p:nvPr/>
        </p:nvSpPr>
        <p:spPr>
          <a:xfrm rot="18777364">
            <a:off x="7130148" y="1979453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01F1E1C-D463-7891-A602-AECD4ADE0CFA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 rot="18777364">
            <a:off x="7407910" y="1677697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95B4135-F47B-5552-0C8E-8D535A9C0BC2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 rot="18777364">
            <a:off x="7820740" y="1742229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DC03CF8A-BD02-638A-A3C1-9607A3FF4C1D}"/>
              </a:ext>
            </a:extLst>
          </p:cNvPr>
          <p:cNvSpPr txBox="1"/>
          <p:nvPr/>
        </p:nvSpPr>
        <p:spPr>
          <a:xfrm>
            <a:off x="1576858" y="6190640"/>
            <a:ext cx="1580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n manuscript:</a:t>
            </a:r>
            <a:endParaRPr lang="zh-CN" altLang="en-US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751A880-7ED8-0FAC-205D-4852DA821490}"/>
              </a:ext>
            </a:extLst>
          </p:cNvPr>
          <p:cNvSpPr txBox="1"/>
          <p:nvPr/>
        </p:nvSpPr>
        <p:spPr>
          <a:xfrm rot="18777364">
            <a:off x="10167916" y="1932499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B8CD271-0503-6240-54A2-D193AFA02E88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 rot="18777364">
            <a:off x="10445678" y="1630743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0E942259-CFD3-E6A3-9DD8-6385E42F58D7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 rot="18777364">
            <a:off x="10858508" y="1695275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8F6997A6-6102-BFCB-747B-39744AA3C39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06845741"/>
              </p:ext>
            </p:extLst>
          </p:nvPr>
        </p:nvGraphicFramePr>
        <p:xfrm>
          <a:off x="3385145" y="6069183"/>
          <a:ext cx="1035050" cy="271780"/>
        </p:xfrm>
        <a:graphic>
          <a:graphicData uri="http://schemas.openxmlformats.org/drawingml/2006/table">
            <a:tbl>
              <a:tblPr/>
              <a:tblGrid>
                <a:gridCol w="1035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PI3K   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E2DCA3F4-9710-B001-21FC-98DC8B60CC1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094785059"/>
              </p:ext>
            </p:extLst>
          </p:nvPr>
        </p:nvGraphicFramePr>
        <p:xfrm>
          <a:off x="3292566" y="6434423"/>
          <a:ext cx="1035050" cy="271780"/>
        </p:xfrm>
        <a:graphic>
          <a:graphicData uri="http://schemas.openxmlformats.org/drawingml/2006/table">
            <a:tbl>
              <a:tblPr/>
              <a:tblGrid>
                <a:gridCol w="1035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GAPDH     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7" name="图片 6">
            <a:extLst>
              <a:ext uri="{FF2B5EF4-FFF2-40B4-BE49-F238E27FC236}">
                <a16:creationId xmlns:a16="http://schemas.microsoft.com/office/drawing/2014/main" id="{008DD09C-8988-9D24-70EA-E2817A9719D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129372" y="6380496"/>
            <a:ext cx="1535401" cy="323844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D0D24265-69E9-3FEE-DF70-8BD144EAA0C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136993" y="6045863"/>
            <a:ext cx="1546830" cy="289554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7E01C87B-A9E8-5511-2683-FCDE00429784}"/>
              </a:ext>
            </a:extLst>
          </p:cNvPr>
          <p:cNvSpPr txBox="1"/>
          <p:nvPr/>
        </p:nvSpPr>
        <p:spPr>
          <a:xfrm rot="18777364">
            <a:off x="4196575" y="5557354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4C44DBC-5C3D-CF02-ACE2-11F9568FE9AF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 rot="18777364">
            <a:off x="4463398" y="5224773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FA34148-401D-4476-D191-C0FE678AEE11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 rot="18777364">
            <a:off x="4972296" y="5314991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</p:spTree>
    <p:extLst>
      <p:ext uri="{BB962C8B-B14F-4D97-AF65-F5344CB8AC3E}">
        <p14:creationId xmlns:p14="http://schemas.microsoft.com/office/powerpoint/2010/main" val="4680729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BF60910-4731-8A6D-A2FB-F87872101236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98" t="25839" r="44693" b="16720"/>
          <a:stretch/>
        </p:blipFill>
        <p:spPr>
          <a:xfrm>
            <a:off x="6667444" y="2332060"/>
            <a:ext cx="2285272" cy="268175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337C351-CEC4-A666-A895-AE10020613B5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06" t="33018" r="44485" b="15640"/>
          <a:stretch/>
        </p:blipFill>
        <p:spPr>
          <a:xfrm>
            <a:off x="9382476" y="2332060"/>
            <a:ext cx="2487301" cy="260889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2F5FE204-09EC-4DC2-CA23-0362366F746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87" t="32215" r="45431" b="7458"/>
          <a:stretch/>
        </p:blipFill>
        <p:spPr>
          <a:xfrm>
            <a:off x="3448830" y="2213433"/>
            <a:ext cx="2369234" cy="2779273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F18C76D-3400-95EB-2A34-7F83EDB79109}"/>
              </a:ext>
            </a:extLst>
          </p:cNvPr>
          <p:cNvSpPr txBox="1"/>
          <p:nvPr/>
        </p:nvSpPr>
        <p:spPr>
          <a:xfrm>
            <a:off x="2487607" y="3047456"/>
            <a:ext cx="1176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PI3K 85KD</a:t>
            </a:r>
            <a:endParaRPr lang="zh-CN" altLang="en-US" sz="1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4038155-C88E-5BF1-5B20-0E7E668345AD}"/>
              </a:ext>
            </a:extLst>
          </p:cNvPr>
          <p:cNvSpPr txBox="1"/>
          <p:nvPr/>
        </p:nvSpPr>
        <p:spPr>
          <a:xfrm>
            <a:off x="4386756" y="744279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1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F7CBCD5-B054-0EFF-5B43-8E0A62792232}"/>
              </a:ext>
            </a:extLst>
          </p:cNvPr>
          <p:cNvSpPr txBox="1"/>
          <p:nvPr/>
        </p:nvSpPr>
        <p:spPr>
          <a:xfrm>
            <a:off x="7058336" y="744279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2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7F861F9-7E10-29A5-137D-79BCDD7A1508}"/>
              </a:ext>
            </a:extLst>
          </p:cNvPr>
          <p:cNvSpPr txBox="1"/>
          <p:nvPr/>
        </p:nvSpPr>
        <p:spPr>
          <a:xfrm>
            <a:off x="9960707" y="696416"/>
            <a:ext cx="1513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Repeat 3</a:t>
            </a:r>
            <a:endParaRPr lang="zh-CN" altLang="en-US" dirty="0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35E2148A-C312-4D0B-F818-05EBB054255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578" y="2312657"/>
            <a:ext cx="640574" cy="240587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888DA02B-4571-B0DD-D954-24FF76344027}"/>
              </a:ext>
            </a:extLst>
          </p:cNvPr>
          <p:cNvSpPr txBox="1"/>
          <p:nvPr/>
        </p:nvSpPr>
        <p:spPr>
          <a:xfrm>
            <a:off x="609193" y="4756284"/>
            <a:ext cx="12478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Marker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DC4F6C5-E933-5C54-250A-7C26E75098F1}"/>
              </a:ext>
            </a:extLst>
          </p:cNvPr>
          <p:cNvSpPr txBox="1"/>
          <p:nvPr/>
        </p:nvSpPr>
        <p:spPr>
          <a:xfrm rot="18777364">
            <a:off x="4011443" y="1929533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BE1E3F7-DF5A-169A-EAD6-778E4A92E88A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 rot="18777364">
            <a:off x="4289205" y="1627777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0FC4740B-1923-9BB3-1355-18FDBB7084FB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 rot="18777364">
            <a:off x="4702035" y="1692309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9B11C53-65C6-FA73-6960-18670FAA0DE5}"/>
              </a:ext>
            </a:extLst>
          </p:cNvPr>
          <p:cNvSpPr txBox="1"/>
          <p:nvPr/>
        </p:nvSpPr>
        <p:spPr>
          <a:xfrm rot="18777364">
            <a:off x="7130148" y="1979453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01F1E1C-D463-7891-A602-AECD4ADE0CFA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 rot="18777364">
            <a:off x="7407910" y="1677697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95B4135-F47B-5552-0C8E-8D535A9C0BC2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 rot="18777364">
            <a:off x="7820740" y="1742229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DC03CF8A-BD02-638A-A3C1-9607A3FF4C1D}"/>
              </a:ext>
            </a:extLst>
          </p:cNvPr>
          <p:cNvSpPr txBox="1"/>
          <p:nvPr/>
        </p:nvSpPr>
        <p:spPr>
          <a:xfrm>
            <a:off x="1576858" y="6190640"/>
            <a:ext cx="1580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n manuscript:</a:t>
            </a:r>
            <a:endParaRPr lang="zh-CN" altLang="en-US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751A880-7ED8-0FAC-205D-4852DA821490}"/>
              </a:ext>
            </a:extLst>
          </p:cNvPr>
          <p:cNvSpPr txBox="1"/>
          <p:nvPr/>
        </p:nvSpPr>
        <p:spPr>
          <a:xfrm rot="18777364">
            <a:off x="10167916" y="1932499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B8CD271-0503-6240-54A2-D193AFA02E88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 rot="18777364">
            <a:off x="10445678" y="1630743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0E942259-CFD3-E6A3-9DD8-6385E42F58D7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 rot="18777364">
            <a:off x="10858508" y="1695275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graphicFrame>
        <p:nvGraphicFramePr>
          <p:cNvPr id="15" name="表格 14">
            <a:extLst>
              <a:ext uri="{FF2B5EF4-FFF2-40B4-BE49-F238E27FC236}">
                <a16:creationId xmlns:a16="http://schemas.microsoft.com/office/drawing/2014/main" id="{7589B015-7B92-7066-AF28-585979F6375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695026804"/>
              </p:ext>
            </p:extLst>
          </p:nvPr>
        </p:nvGraphicFramePr>
        <p:xfrm>
          <a:off x="3246763" y="6151779"/>
          <a:ext cx="1035050" cy="271780"/>
        </p:xfrm>
        <a:graphic>
          <a:graphicData uri="http://schemas.openxmlformats.org/drawingml/2006/table">
            <a:tbl>
              <a:tblPr/>
              <a:tblGrid>
                <a:gridCol w="1035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p-PI3K  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9" name="表格 18">
            <a:extLst>
              <a:ext uri="{FF2B5EF4-FFF2-40B4-BE49-F238E27FC236}">
                <a16:creationId xmlns:a16="http://schemas.microsoft.com/office/drawing/2014/main" id="{F3A7562A-EC20-E861-3BD9-C638B4DD9FD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56442890"/>
              </p:ext>
            </p:extLst>
          </p:nvPr>
        </p:nvGraphicFramePr>
        <p:xfrm>
          <a:off x="3184620" y="6522691"/>
          <a:ext cx="1035050" cy="271780"/>
        </p:xfrm>
        <a:graphic>
          <a:graphicData uri="http://schemas.openxmlformats.org/drawingml/2006/table">
            <a:tbl>
              <a:tblPr/>
              <a:tblGrid>
                <a:gridCol w="1035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GAPDH     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21" name="图片 20">
            <a:extLst>
              <a:ext uri="{FF2B5EF4-FFF2-40B4-BE49-F238E27FC236}">
                <a16:creationId xmlns:a16="http://schemas.microsoft.com/office/drawing/2014/main" id="{AB5C530C-361C-96FA-D305-C069E5F3950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42366" y="6490017"/>
            <a:ext cx="1493491" cy="354323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6C29FAAF-DE7A-23FC-1F5A-2B19F0175D5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038555" y="6113721"/>
            <a:ext cx="1531591" cy="323844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884A2BAB-18AF-4374-3686-5C67EE854019}"/>
              </a:ext>
            </a:extLst>
          </p:cNvPr>
          <p:cNvSpPr txBox="1"/>
          <p:nvPr/>
        </p:nvSpPr>
        <p:spPr>
          <a:xfrm rot="18777364">
            <a:off x="4051465" y="5620130"/>
            <a:ext cx="949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3F50A77-9524-76D0-43A8-3B43F2CAA2F7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 rot="18777364">
            <a:off x="4318288" y="5287549"/>
            <a:ext cx="179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80094C7-8F93-41B3-6B24-38A6C406EB34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 rot="18777364">
            <a:off x="4827186" y="5377767"/>
            <a:ext cx="16116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0  </a:t>
            </a:r>
            <a:r>
              <a:rPr lang="en-US" altLang="zh-CN" sz="1200" dirty="0" err="1"/>
              <a:t>μmol</a:t>
            </a:r>
            <a:r>
              <a:rPr lang="en-US" altLang="zh-CN" sz="1200" dirty="0"/>
              <a:t>/L flavone</a:t>
            </a:r>
          </a:p>
        </p:txBody>
      </p:sp>
    </p:spTree>
    <p:extLst>
      <p:ext uri="{BB962C8B-B14F-4D97-AF65-F5344CB8AC3E}">
        <p14:creationId xmlns:p14="http://schemas.microsoft.com/office/powerpoint/2010/main" val="60706916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7</TotalTime>
  <Words>232</Words>
  <Application>Microsoft Office PowerPoint</Application>
  <PresentationFormat>宽屏</PresentationFormat>
  <Paragraphs>80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越 卓</dc:creator>
  <cp:lastModifiedBy>m m</cp:lastModifiedBy>
  <cp:revision>15</cp:revision>
  <dcterms:created xsi:type="dcterms:W3CDTF">2024-04-25T10:31:08Z</dcterms:created>
  <dcterms:modified xsi:type="dcterms:W3CDTF">2024-04-26T15:39:56Z</dcterms:modified>
</cp:coreProperties>
</file>